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2" r:id="rId2"/>
    <p:sldId id="271" r:id="rId3"/>
    <p:sldId id="264" r:id="rId4"/>
    <p:sldId id="265" r:id="rId5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415"/>
    <p:restoredTop sz="94628"/>
  </p:normalViewPr>
  <p:slideViewPr>
    <p:cSldViewPr snapToGrid="0" snapToObjects="1">
      <p:cViewPr varScale="1">
        <p:scale>
          <a:sx n="119" d="100"/>
          <a:sy n="119" d="100"/>
        </p:scale>
        <p:origin x="156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E8F2D9-93BC-424F-AEDA-F54186ADBE16}" type="datetimeFigureOut">
              <a:rPr lang="en-US" smtClean="0"/>
              <a:t>8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79C2E7-242B-1D41-BC44-6038F7DB80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53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0E1D9-DE6F-AE41-AD5F-51B37F866D58}" type="datetime1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25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AB16-A34A-B040-9422-BE46A5CC5C93}" type="datetime1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38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79371-A5A7-0D41-9800-0B6D1541F833}" type="datetime1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801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48CE1-0FDA-9445-A38A-28972700692C}" type="datetime1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206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D19C3-9784-EB44-9275-CA115C1CFC71}" type="datetime1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15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C8146-D09E-7849-B80F-D1D7CAFC1F56}" type="datetime1">
              <a:rPr lang="en-US" smtClean="0"/>
              <a:t>8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781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901CC-2E69-A14B-8E30-A39FADF0581F}" type="datetime1">
              <a:rPr lang="en-US" smtClean="0"/>
              <a:t>8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164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22A9B-5E54-E84D-AE30-06DD6299046D}" type="datetime1">
              <a:rPr lang="en-US" smtClean="0"/>
              <a:t>8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684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A8048-0C71-2647-8FA0-5C64B105098D}" type="datetime1">
              <a:rPr lang="en-US" smtClean="0"/>
              <a:t>8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455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E1109-6184-DE48-93B1-C11172311233}" type="datetime1">
              <a:rPr lang="en-US" smtClean="0"/>
              <a:t>8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09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DBA60-A2D9-BF4F-A4CD-D5594AE5A095}" type="datetime1">
              <a:rPr lang="en-US" smtClean="0"/>
              <a:t>8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618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666A4-D9FA-014F-A411-40D96357622F}" type="datetime1">
              <a:rPr lang="en-US" smtClean="0"/>
              <a:t>8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9850A-6D2B-4B4A-9913-4B67AC04D7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88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9267FE4-2370-0E43-916A-90E1E09FB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559901"/>
            <a:ext cx="7886700" cy="559212"/>
          </a:xfrm>
        </p:spPr>
        <p:txBody>
          <a:bodyPr>
            <a:normAutofit/>
          </a:bodyPr>
          <a:lstStyle/>
          <a:p>
            <a:pPr lvl="0" defTabSz="457200">
              <a:lnSpc>
                <a:spcPct val="100000"/>
              </a:lnSpc>
              <a:spcBef>
                <a:spcPts val="0"/>
              </a:spcBef>
            </a:pPr>
            <a:r>
              <a:rPr lang="en-US" sz="1800" b="1" dirty="0">
                <a:solidFill>
                  <a:prstClr val="black"/>
                </a:solidFill>
                <a:latin typeface="Calibri" panose="020F0502020204030204"/>
                <a:ea typeface="+mn-ea"/>
                <a:cs typeface="+mn-cs"/>
              </a:rPr>
              <a:t>Feasibility</a:t>
            </a:r>
            <a:endParaRPr lang="en-US" dirty="0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257DFBFA-5EEF-4242-B0B5-0C6025C5F017}"/>
              </a:ext>
            </a:extLst>
          </p:cNvPr>
          <p:cNvSpPr txBox="1">
            <a:spLocks/>
          </p:cNvSpPr>
          <p:nvPr/>
        </p:nvSpPr>
        <p:spPr>
          <a:xfrm>
            <a:off x="326632" y="1448811"/>
            <a:ext cx="5139219" cy="4506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dirty="0">
                <a:latin typeface="+mn-lt"/>
              </a:rPr>
              <a:t>Q: To what extend do you agree with the following statement for this session? </a:t>
            </a:r>
          </a:p>
          <a:p>
            <a:pPr algn="ctr"/>
            <a:r>
              <a:rPr lang="en-US" sz="1200" b="1" i="1" dirty="0">
                <a:latin typeface="+mn-lt"/>
              </a:rPr>
              <a:t>It was easy to schedule the coaching observation of a telehealth encounter.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E2F0A6E1-7512-0141-911B-11D473DD50E7}"/>
              </a:ext>
            </a:extLst>
          </p:cNvPr>
          <p:cNvSpPr txBox="1">
            <a:spLocks/>
          </p:cNvSpPr>
          <p:nvPr/>
        </p:nvSpPr>
        <p:spPr>
          <a:xfrm>
            <a:off x="326632" y="3583508"/>
            <a:ext cx="5031444" cy="962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dirty="0">
                <a:latin typeface="+mn-lt"/>
              </a:rPr>
              <a:t>Q: To what extend do you agree with the following statement for this session? </a:t>
            </a:r>
          </a:p>
          <a:p>
            <a:pPr algn="ctr"/>
            <a:r>
              <a:rPr lang="en-US" sz="1200" b="1" i="1" dirty="0">
                <a:latin typeface="+mn-lt"/>
              </a:rPr>
              <a:t>It was easy to schedule the debriefing session with my coach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Resident)</a:t>
            </a:r>
          </a:p>
          <a:p>
            <a:pPr algn="ctr"/>
            <a:r>
              <a:rPr lang="en-US" sz="1200" dirty="0">
                <a:solidFill>
                  <a:srgbClr val="FF0000"/>
                </a:solidFill>
                <a:latin typeface="+mn-lt"/>
              </a:rPr>
              <a:t>OR</a:t>
            </a:r>
          </a:p>
          <a:p>
            <a:pPr algn="ctr"/>
            <a:r>
              <a:rPr lang="en-US" sz="1200" b="1" i="1" dirty="0">
                <a:latin typeface="+mn-lt"/>
              </a:rPr>
              <a:t>It was easy to schedule the debriefing session with the resident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Coach)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B9D29B83-9451-284F-8D42-55B920D5C120}"/>
              </a:ext>
            </a:extLst>
          </p:cNvPr>
          <p:cNvSpPr txBox="1">
            <a:spLocks/>
          </p:cNvSpPr>
          <p:nvPr/>
        </p:nvSpPr>
        <p:spPr>
          <a:xfrm>
            <a:off x="5465851" y="2713952"/>
            <a:ext cx="3565132" cy="5592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dirty="0">
                <a:latin typeface="+mn-lt"/>
              </a:rPr>
              <a:t>Did you experience any technical difficulties during the coaching observation of a telehealth encounter?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23BD555-D9E1-8D4F-977F-B507E609D9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337745"/>
              </p:ext>
            </p:extLst>
          </p:nvPr>
        </p:nvGraphicFramePr>
        <p:xfrm>
          <a:off x="393515" y="2081048"/>
          <a:ext cx="4964561" cy="1320859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81193">
                  <a:extLst>
                    <a:ext uri="{9D8B030D-6E8A-4147-A177-3AD203B41FA5}">
                      <a16:colId xmlns:a16="http://schemas.microsoft.com/office/drawing/2014/main" val="1630874354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4103917746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547051350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3342391958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1491322514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1097686017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1263954293"/>
                    </a:ext>
                  </a:extLst>
                </a:gridCol>
              </a:tblGrid>
              <a:tr h="177859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20762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662228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t at all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102241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light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7563432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derate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4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22181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very much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9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46947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5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9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95460657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18B129BC-73AF-D042-99AE-EC5DBF97A6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814106"/>
              </p:ext>
            </p:extLst>
          </p:nvPr>
        </p:nvGraphicFramePr>
        <p:xfrm>
          <a:off x="393516" y="4742439"/>
          <a:ext cx="4964561" cy="13335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81193">
                  <a:extLst>
                    <a:ext uri="{9D8B030D-6E8A-4147-A177-3AD203B41FA5}">
                      <a16:colId xmlns:a16="http://schemas.microsoft.com/office/drawing/2014/main" val="2117062826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2499297248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1406653890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3428164125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1071511121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3099687944"/>
                    </a:ext>
                  </a:extLst>
                </a:gridCol>
                <a:gridCol w="647228">
                  <a:extLst>
                    <a:ext uri="{9D8B030D-6E8A-4147-A177-3AD203B41FA5}">
                      <a16:colId xmlns:a16="http://schemas.microsoft.com/office/drawing/2014/main" val="1573731690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02063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202361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t at all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246884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light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629027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derate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46497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very much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56745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7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6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9197691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61610F5-59EC-D84C-BB17-1671090F0A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7948945"/>
              </p:ext>
            </p:extLst>
          </p:nvPr>
        </p:nvGraphicFramePr>
        <p:xfrm>
          <a:off x="5451146" y="3440300"/>
          <a:ext cx="3594541" cy="7620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82827">
                  <a:extLst>
                    <a:ext uri="{9D8B030D-6E8A-4147-A177-3AD203B41FA5}">
                      <a16:colId xmlns:a16="http://schemas.microsoft.com/office/drawing/2014/main" val="3950987008"/>
                    </a:ext>
                  </a:extLst>
                </a:gridCol>
                <a:gridCol w="468619">
                  <a:extLst>
                    <a:ext uri="{9D8B030D-6E8A-4147-A177-3AD203B41FA5}">
                      <a16:colId xmlns:a16="http://schemas.microsoft.com/office/drawing/2014/main" val="457039465"/>
                    </a:ext>
                  </a:extLst>
                </a:gridCol>
                <a:gridCol w="468619">
                  <a:extLst>
                    <a:ext uri="{9D8B030D-6E8A-4147-A177-3AD203B41FA5}">
                      <a16:colId xmlns:a16="http://schemas.microsoft.com/office/drawing/2014/main" val="660438511"/>
                    </a:ext>
                  </a:extLst>
                </a:gridCol>
                <a:gridCol w="468619">
                  <a:extLst>
                    <a:ext uri="{9D8B030D-6E8A-4147-A177-3AD203B41FA5}">
                      <a16:colId xmlns:a16="http://schemas.microsoft.com/office/drawing/2014/main" val="459148906"/>
                    </a:ext>
                  </a:extLst>
                </a:gridCol>
                <a:gridCol w="468619">
                  <a:extLst>
                    <a:ext uri="{9D8B030D-6E8A-4147-A177-3AD203B41FA5}">
                      <a16:colId xmlns:a16="http://schemas.microsoft.com/office/drawing/2014/main" val="2208643436"/>
                    </a:ext>
                  </a:extLst>
                </a:gridCol>
                <a:gridCol w="468619">
                  <a:extLst>
                    <a:ext uri="{9D8B030D-6E8A-4147-A177-3AD203B41FA5}">
                      <a16:colId xmlns:a16="http://schemas.microsoft.com/office/drawing/2014/main" val="1361470492"/>
                    </a:ext>
                  </a:extLst>
                </a:gridCol>
                <a:gridCol w="468619">
                  <a:extLst>
                    <a:ext uri="{9D8B030D-6E8A-4147-A177-3AD203B41FA5}">
                      <a16:colId xmlns:a16="http://schemas.microsoft.com/office/drawing/2014/main" val="191164756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269171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896557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861459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8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9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7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8580026"/>
                  </a:ext>
                </a:extLst>
              </a:tr>
            </a:tbl>
          </a:graphicData>
        </a:graphic>
      </p:graphicFrame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CBCAC73-249D-C24F-AEAE-73B270041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1</a:t>
            </a:fld>
            <a:endParaRPr lang="en-US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C7300A66-D468-2946-AC58-BCA7292E0F8D}"/>
              </a:ext>
            </a:extLst>
          </p:cNvPr>
          <p:cNvSpPr txBox="1">
            <a:spLocks/>
          </p:cNvSpPr>
          <p:nvPr/>
        </p:nvSpPr>
        <p:spPr>
          <a:xfrm>
            <a:off x="129092" y="182500"/>
            <a:ext cx="8046720" cy="4518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+mn-lt"/>
              </a:rPr>
              <a:t>Feasibility, Acceptability, and Perceived Usefulness of Virtually Coaching Residents on Communication Skills: Findings Differentiated Between Residents and Coaches</a:t>
            </a:r>
            <a:endParaRPr lang="en-US" sz="30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769956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9267FE4-2370-0E43-916A-90E1E09FB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559212"/>
          </a:xfrm>
        </p:spPr>
        <p:txBody>
          <a:bodyPr>
            <a:normAutofit/>
          </a:bodyPr>
          <a:lstStyle/>
          <a:p>
            <a:pPr lvl="0" defTabSz="457200">
              <a:lnSpc>
                <a:spcPct val="100000"/>
              </a:lnSpc>
              <a:spcBef>
                <a:spcPts val="0"/>
              </a:spcBef>
            </a:pPr>
            <a:r>
              <a:rPr lang="en-US" sz="1800" b="1" dirty="0">
                <a:solidFill>
                  <a:prstClr val="black"/>
                </a:solidFill>
                <a:latin typeface="Calibri" panose="020F0502020204030204"/>
                <a:ea typeface="+mn-ea"/>
                <a:cs typeface="+mn-cs"/>
              </a:rPr>
              <a:t>Acceptability</a:t>
            </a:r>
            <a:endParaRPr lang="en-US" dirty="0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257DFBFA-5EEF-4242-B0B5-0C6025C5F017}"/>
              </a:ext>
            </a:extLst>
          </p:cNvPr>
          <p:cNvSpPr txBox="1">
            <a:spLocks/>
          </p:cNvSpPr>
          <p:nvPr/>
        </p:nvSpPr>
        <p:spPr>
          <a:xfrm>
            <a:off x="628650" y="1768567"/>
            <a:ext cx="7886700" cy="1169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i="1" dirty="0">
                <a:latin typeface="+mn-lt"/>
              </a:rPr>
              <a:t>To what extent did the presence of the virtual coach disrupt the relationship you had with the patient during the telehealth encounter? 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Resident)</a:t>
            </a:r>
          </a:p>
          <a:p>
            <a:pPr algn="ctr"/>
            <a:r>
              <a:rPr lang="en-US" sz="1200" i="1" dirty="0">
                <a:solidFill>
                  <a:srgbClr val="FF0000"/>
                </a:solidFill>
                <a:latin typeface="+mn-lt"/>
              </a:rPr>
              <a:t>OR</a:t>
            </a:r>
            <a:r>
              <a:rPr lang="en-US" sz="1200" b="1" i="1" dirty="0">
                <a:latin typeface="+mn-lt"/>
              </a:rPr>
              <a:t> </a:t>
            </a:r>
          </a:p>
          <a:p>
            <a:pPr algn="ctr"/>
            <a:r>
              <a:rPr lang="en-US" sz="1200" b="1" i="1" dirty="0">
                <a:latin typeface="+mn-lt"/>
              </a:rPr>
              <a:t>To what extent did your presence disrupt the relationship the resident had with the patient during the telehealth encounter?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Coach)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BDF42A1-5A2E-744F-B60A-CBB22582A1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467438"/>
              </p:ext>
            </p:extLst>
          </p:nvPr>
        </p:nvGraphicFramePr>
        <p:xfrm>
          <a:off x="1718551" y="3252843"/>
          <a:ext cx="5706897" cy="13335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242861">
                  <a:extLst>
                    <a:ext uri="{9D8B030D-6E8A-4147-A177-3AD203B41FA5}">
                      <a16:colId xmlns:a16="http://schemas.microsoft.com/office/drawing/2014/main" val="2877456495"/>
                    </a:ext>
                  </a:extLst>
                </a:gridCol>
                <a:gridCol w="744006">
                  <a:extLst>
                    <a:ext uri="{9D8B030D-6E8A-4147-A177-3AD203B41FA5}">
                      <a16:colId xmlns:a16="http://schemas.microsoft.com/office/drawing/2014/main" val="109268162"/>
                    </a:ext>
                  </a:extLst>
                </a:gridCol>
                <a:gridCol w="744006">
                  <a:extLst>
                    <a:ext uri="{9D8B030D-6E8A-4147-A177-3AD203B41FA5}">
                      <a16:colId xmlns:a16="http://schemas.microsoft.com/office/drawing/2014/main" val="2238542380"/>
                    </a:ext>
                  </a:extLst>
                </a:gridCol>
                <a:gridCol w="744006">
                  <a:extLst>
                    <a:ext uri="{9D8B030D-6E8A-4147-A177-3AD203B41FA5}">
                      <a16:colId xmlns:a16="http://schemas.microsoft.com/office/drawing/2014/main" val="3689670521"/>
                    </a:ext>
                  </a:extLst>
                </a:gridCol>
                <a:gridCol w="744006">
                  <a:extLst>
                    <a:ext uri="{9D8B030D-6E8A-4147-A177-3AD203B41FA5}">
                      <a16:colId xmlns:a16="http://schemas.microsoft.com/office/drawing/2014/main" val="1242641571"/>
                    </a:ext>
                  </a:extLst>
                </a:gridCol>
                <a:gridCol w="744006">
                  <a:extLst>
                    <a:ext uri="{9D8B030D-6E8A-4147-A177-3AD203B41FA5}">
                      <a16:colId xmlns:a16="http://schemas.microsoft.com/office/drawing/2014/main" val="2149429244"/>
                    </a:ext>
                  </a:extLst>
                </a:gridCol>
                <a:gridCol w="744006">
                  <a:extLst>
                    <a:ext uri="{9D8B030D-6E8A-4147-A177-3AD203B41FA5}">
                      <a16:colId xmlns:a16="http://schemas.microsoft.com/office/drawing/2014/main" val="1921426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785356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462622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t at all disrup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7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7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7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853805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lightly disrup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247062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omewhat disrup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243694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very disrup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772075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extremely disruptiv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34285092"/>
                  </a:ext>
                </a:extLst>
              </a:tr>
            </a:tbl>
          </a:graphicData>
        </a:graphic>
      </p:graphicFrame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C568703-71B9-9549-A495-BC3CE31D7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804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9267FE4-2370-0E43-916A-90E1E09FB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559212"/>
          </a:xfrm>
        </p:spPr>
        <p:txBody>
          <a:bodyPr>
            <a:normAutofit/>
          </a:bodyPr>
          <a:lstStyle/>
          <a:p>
            <a:pPr lvl="0" defTabSz="457200">
              <a:lnSpc>
                <a:spcPct val="100000"/>
              </a:lnSpc>
              <a:spcBef>
                <a:spcPts val="0"/>
              </a:spcBef>
            </a:pPr>
            <a:r>
              <a:rPr lang="en-US" sz="1800" b="1" dirty="0">
                <a:solidFill>
                  <a:prstClr val="black"/>
                </a:solidFill>
                <a:latin typeface="Calibri" panose="020F0502020204030204"/>
                <a:ea typeface="+mn-ea"/>
                <a:cs typeface="+mn-cs"/>
              </a:rPr>
              <a:t>Perceived Usefulness</a:t>
            </a:r>
            <a:endParaRPr lang="en-US" dirty="0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257DFBFA-5EEF-4242-B0B5-0C6025C5F017}"/>
              </a:ext>
            </a:extLst>
          </p:cNvPr>
          <p:cNvSpPr txBox="1">
            <a:spLocks/>
          </p:cNvSpPr>
          <p:nvPr/>
        </p:nvSpPr>
        <p:spPr>
          <a:xfrm>
            <a:off x="628650" y="924339"/>
            <a:ext cx="5158964" cy="2982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+mn-lt"/>
              </a:rPr>
              <a:t>Q: To what extent do you agree with the following statements for this session?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0F918697-B5EA-6B4F-BB85-38BACD569BA5}"/>
              </a:ext>
            </a:extLst>
          </p:cNvPr>
          <p:cNvSpPr txBox="1">
            <a:spLocks/>
          </p:cNvSpPr>
          <p:nvPr/>
        </p:nvSpPr>
        <p:spPr>
          <a:xfrm>
            <a:off x="584663" y="1334407"/>
            <a:ext cx="7886700" cy="6597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i="1" dirty="0">
                <a:latin typeface="+mn-lt"/>
              </a:rPr>
              <a:t>The facilitated self-reflection with my coach was useful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Resident)</a:t>
            </a:r>
          </a:p>
          <a:p>
            <a:pPr algn="ctr"/>
            <a:r>
              <a:rPr lang="en-US" sz="1200" dirty="0">
                <a:solidFill>
                  <a:srgbClr val="FF0000"/>
                </a:solidFill>
                <a:latin typeface="+mn-lt"/>
              </a:rPr>
              <a:t>OR</a:t>
            </a:r>
          </a:p>
          <a:p>
            <a:pPr algn="ctr"/>
            <a:r>
              <a:rPr lang="en-US" sz="1200" b="1" i="1" dirty="0">
                <a:latin typeface="+mn-lt"/>
              </a:rPr>
              <a:t>The facilitated self-reflection was useful for the resident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Coach)</a:t>
            </a: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C2773F9B-8655-8841-9537-178776BED64E}"/>
              </a:ext>
            </a:extLst>
          </p:cNvPr>
          <p:cNvSpPr txBox="1">
            <a:spLocks/>
          </p:cNvSpPr>
          <p:nvPr/>
        </p:nvSpPr>
        <p:spPr>
          <a:xfrm>
            <a:off x="985837" y="3913644"/>
            <a:ext cx="7172325" cy="659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i="1" dirty="0">
                <a:latin typeface="+mn-lt"/>
              </a:rPr>
              <a:t>The feedback I received from faculty coach was useful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Resident)</a:t>
            </a:r>
          </a:p>
          <a:p>
            <a:pPr algn="ctr"/>
            <a:r>
              <a:rPr lang="en-US" sz="1200" dirty="0">
                <a:solidFill>
                  <a:srgbClr val="FF0000"/>
                </a:solidFill>
                <a:latin typeface="+mn-lt"/>
              </a:rPr>
              <a:t>OR</a:t>
            </a:r>
          </a:p>
          <a:p>
            <a:pPr algn="ctr"/>
            <a:r>
              <a:rPr lang="en-US" sz="1200" b="1" i="1" dirty="0">
                <a:latin typeface="+mn-lt"/>
              </a:rPr>
              <a:t>The feedback I provided was useful for the resident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Coach)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611FC85-8728-844C-A9A7-C5862F2C55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9830897"/>
              </p:ext>
            </p:extLst>
          </p:nvPr>
        </p:nvGraphicFramePr>
        <p:xfrm>
          <a:off x="1965575" y="2124838"/>
          <a:ext cx="5124876" cy="13335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116108">
                  <a:extLst>
                    <a:ext uri="{9D8B030D-6E8A-4147-A177-3AD203B41FA5}">
                      <a16:colId xmlns:a16="http://schemas.microsoft.com/office/drawing/2014/main" val="3930683654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3372176625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3065119463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143032903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2812655252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3432336617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362547914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747989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628255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t at all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570373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light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747615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derate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213672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very much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034580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15139634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77C79F17-3AF7-FD47-854A-04DB0D9971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1937466"/>
              </p:ext>
            </p:extLst>
          </p:nvPr>
        </p:nvGraphicFramePr>
        <p:xfrm>
          <a:off x="1965575" y="4600161"/>
          <a:ext cx="5124876" cy="13335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116108">
                  <a:extLst>
                    <a:ext uri="{9D8B030D-6E8A-4147-A177-3AD203B41FA5}">
                      <a16:colId xmlns:a16="http://schemas.microsoft.com/office/drawing/2014/main" val="4088699141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3060371663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3937392269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972345258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1703553189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1981199898"/>
                    </a:ext>
                  </a:extLst>
                </a:gridCol>
                <a:gridCol w="668128">
                  <a:extLst>
                    <a:ext uri="{9D8B030D-6E8A-4147-A177-3AD203B41FA5}">
                      <a16:colId xmlns:a16="http://schemas.microsoft.com/office/drawing/2014/main" val="274214242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8124005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396728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t at all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032866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light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92189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derate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645367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very much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519684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89740790"/>
                  </a:ext>
                </a:extLst>
              </a:tr>
            </a:tbl>
          </a:graphicData>
        </a:graphic>
      </p:graphicFrame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B44582A-4FB6-1345-AD0C-EF99EBB3C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100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9267FE4-2370-0E43-916A-90E1E09FB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559212"/>
          </a:xfrm>
        </p:spPr>
        <p:txBody>
          <a:bodyPr>
            <a:normAutofit/>
          </a:bodyPr>
          <a:lstStyle/>
          <a:p>
            <a:pPr lvl="0" defTabSz="457200">
              <a:lnSpc>
                <a:spcPct val="100000"/>
              </a:lnSpc>
              <a:spcBef>
                <a:spcPts val="0"/>
              </a:spcBef>
            </a:pPr>
            <a:r>
              <a:rPr lang="en-US" sz="1800" b="1" dirty="0">
                <a:solidFill>
                  <a:prstClr val="black"/>
                </a:solidFill>
                <a:latin typeface="Calibri" panose="020F0502020204030204"/>
                <a:ea typeface="+mn-ea"/>
                <a:cs typeface="+mn-cs"/>
              </a:rPr>
              <a:t>Perceived Usefulness</a:t>
            </a:r>
            <a:endParaRPr lang="en-US" dirty="0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257DFBFA-5EEF-4242-B0B5-0C6025C5F017}"/>
              </a:ext>
            </a:extLst>
          </p:cNvPr>
          <p:cNvSpPr txBox="1">
            <a:spLocks/>
          </p:cNvSpPr>
          <p:nvPr/>
        </p:nvSpPr>
        <p:spPr>
          <a:xfrm>
            <a:off x="628650" y="924339"/>
            <a:ext cx="5288056" cy="2982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+mn-lt"/>
              </a:rPr>
              <a:t>Q: To what extent do you agree with the following statements for this session?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85C54C2C-36BE-CD42-A2A5-C1A8EFC72B97}"/>
              </a:ext>
            </a:extLst>
          </p:cNvPr>
          <p:cNvSpPr txBox="1">
            <a:spLocks/>
          </p:cNvSpPr>
          <p:nvPr/>
        </p:nvSpPr>
        <p:spPr>
          <a:xfrm>
            <a:off x="513226" y="1895293"/>
            <a:ext cx="8117548" cy="5592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39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i="1" dirty="0">
                <a:latin typeface="+mn-lt"/>
              </a:rPr>
              <a:t>My takeaways from this coaching session will be useful for my future telehealth encounters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Resident)</a:t>
            </a:r>
          </a:p>
          <a:p>
            <a:pPr algn="ctr"/>
            <a:r>
              <a:rPr lang="en-US" sz="1200" dirty="0">
                <a:solidFill>
                  <a:srgbClr val="FF0000"/>
                </a:solidFill>
                <a:latin typeface="+mn-lt"/>
              </a:rPr>
              <a:t>OR</a:t>
            </a:r>
          </a:p>
          <a:p>
            <a:pPr algn="ctr"/>
            <a:r>
              <a:rPr lang="en-US" sz="1200" b="1" i="1" dirty="0">
                <a:latin typeface="+mn-lt"/>
              </a:rPr>
              <a:t>The takeaways from this coaching session will be useful for the resident’s future telehealth encounters. </a:t>
            </a:r>
            <a:r>
              <a:rPr lang="en-US" sz="1200" dirty="0">
                <a:solidFill>
                  <a:srgbClr val="FF0000"/>
                </a:solidFill>
                <a:latin typeface="+mn-lt"/>
              </a:rPr>
              <a:t>(Coach)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A186A4A-6298-2E45-9DC1-2F9B150B14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1299479"/>
              </p:ext>
            </p:extLst>
          </p:nvPr>
        </p:nvGraphicFramePr>
        <p:xfrm>
          <a:off x="2170881" y="2926957"/>
          <a:ext cx="4802238" cy="133350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045842">
                  <a:extLst>
                    <a:ext uri="{9D8B030D-6E8A-4147-A177-3AD203B41FA5}">
                      <a16:colId xmlns:a16="http://schemas.microsoft.com/office/drawing/2014/main" val="647372077"/>
                    </a:ext>
                  </a:extLst>
                </a:gridCol>
                <a:gridCol w="626066">
                  <a:extLst>
                    <a:ext uri="{9D8B030D-6E8A-4147-A177-3AD203B41FA5}">
                      <a16:colId xmlns:a16="http://schemas.microsoft.com/office/drawing/2014/main" val="2005808781"/>
                    </a:ext>
                  </a:extLst>
                </a:gridCol>
                <a:gridCol w="626066">
                  <a:extLst>
                    <a:ext uri="{9D8B030D-6E8A-4147-A177-3AD203B41FA5}">
                      <a16:colId xmlns:a16="http://schemas.microsoft.com/office/drawing/2014/main" val="1085196578"/>
                    </a:ext>
                  </a:extLst>
                </a:gridCol>
                <a:gridCol w="626066">
                  <a:extLst>
                    <a:ext uri="{9D8B030D-6E8A-4147-A177-3AD203B41FA5}">
                      <a16:colId xmlns:a16="http://schemas.microsoft.com/office/drawing/2014/main" val="792763011"/>
                    </a:ext>
                  </a:extLst>
                </a:gridCol>
                <a:gridCol w="626066">
                  <a:extLst>
                    <a:ext uri="{9D8B030D-6E8A-4147-A177-3AD203B41FA5}">
                      <a16:colId xmlns:a16="http://schemas.microsoft.com/office/drawing/2014/main" val="1563722857"/>
                    </a:ext>
                  </a:extLst>
                </a:gridCol>
                <a:gridCol w="626066">
                  <a:extLst>
                    <a:ext uri="{9D8B030D-6E8A-4147-A177-3AD203B41FA5}">
                      <a16:colId xmlns:a16="http://schemas.microsoft.com/office/drawing/2014/main" val="1317954547"/>
                    </a:ext>
                  </a:extLst>
                </a:gridCol>
                <a:gridCol w="626066">
                  <a:extLst>
                    <a:ext uri="{9D8B030D-6E8A-4147-A177-3AD203B41FA5}">
                      <a16:colId xmlns:a16="http://schemas.microsoft.com/office/drawing/2014/main" val="73170098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overa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reside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coach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564909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</a:rPr>
                        <a:t>%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%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63012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ot at all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472923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light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4994964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derate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1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6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540946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very much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6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8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724204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ully agre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2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%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3%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81217574"/>
                  </a:ext>
                </a:extLst>
              </a:tr>
            </a:tbl>
          </a:graphicData>
        </a:graphic>
      </p:graphicFrame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F6107223-27C7-1B4F-ABC2-1572210D3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9850A-6D2B-4B4A-9913-4B67AC04D73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81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2</TotalTime>
  <Words>724</Words>
  <Application>Microsoft Macintosh PowerPoint</Application>
  <PresentationFormat>Letter Paper (8.5x11 in)</PresentationFormat>
  <Paragraphs>3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Feasibility</vt:lpstr>
      <vt:lpstr>Acceptability</vt:lpstr>
      <vt:lpstr>Perceived Usefulness</vt:lpstr>
      <vt:lpstr>Perceived Usefulnes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valuation of Communication Coaching on Telehealth Encounters Survey</dc:title>
  <dc:creator>Marzena Sasnal</dc:creator>
  <cp:lastModifiedBy>Marzena Sasnal</cp:lastModifiedBy>
  <cp:revision>68</cp:revision>
  <cp:lastPrinted>2021-08-12T17:12:57Z</cp:lastPrinted>
  <dcterms:created xsi:type="dcterms:W3CDTF">2020-06-25T21:08:06Z</dcterms:created>
  <dcterms:modified xsi:type="dcterms:W3CDTF">2021-08-12T17:15:04Z</dcterms:modified>
</cp:coreProperties>
</file>